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  <p:sldId id="257" r:id="rId5"/>
  </p:sldIdLst>
  <p:sldSz cx="6264275" cy="835183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709972-37A4-4E66-99B9-7D0454237FC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29840" y="444600"/>
            <a:ext cx="5403960" cy="161424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3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29840" y="2224080"/>
            <a:ext cx="5403960" cy="252756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29840" y="4992120"/>
            <a:ext cx="5403960" cy="252756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ADB75C-9F9B-4E44-B222-C1780F30C06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29840" y="444600"/>
            <a:ext cx="5403960" cy="161424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3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29840" y="2224080"/>
            <a:ext cx="2637000" cy="252756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198960" y="2224080"/>
            <a:ext cx="2637000" cy="252756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29840" y="4992120"/>
            <a:ext cx="2637000" cy="252756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198960" y="4992120"/>
            <a:ext cx="2637000" cy="252756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56BC22-C38F-4A36-A4E7-8B5ADA07F16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29840" y="444600"/>
            <a:ext cx="5403960" cy="161424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3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29840" y="2224080"/>
            <a:ext cx="1739880" cy="252756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257200" y="2224080"/>
            <a:ext cx="1739880" cy="252756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084200" y="2224080"/>
            <a:ext cx="1739880" cy="252756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29840" y="4992120"/>
            <a:ext cx="1739880" cy="252756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257200" y="4992120"/>
            <a:ext cx="1739880" cy="252756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084200" y="4992120"/>
            <a:ext cx="1739880" cy="252756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E52397-16F3-4B94-A54E-37F05B5A576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CAC8A55-D2A2-471D-9A49-3BC684BB904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29840" y="444600"/>
            <a:ext cx="5403960" cy="161424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3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429840" y="2224080"/>
            <a:ext cx="5403960" cy="5299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689"/>
              </a:spcBef>
              <a:buNone/>
              <a:tabLst>
                <a:tab algn="l" pos="0"/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EDDCF0C-7B62-4D69-B2C1-32B2769BF93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29840" y="444600"/>
            <a:ext cx="5403960" cy="161424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3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429840" y="2224080"/>
            <a:ext cx="5403960" cy="529920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2059C4E-184E-435F-88ED-E472D1AB1F6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29840" y="444600"/>
            <a:ext cx="5403960" cy="161424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3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29840" y="2224080"/>
            <a:ext cx="2637000" cy="529920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3198960" y="2224080"/>
            <a:ext cx="2637000" cy="529920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B4CD38F-4844-4253-AE7B-6EB5D803B1C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29840" y="444600"/>
            <a:ext cx="5403960" cy="161424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3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00C9435-4C80-48DF-8C12-EEC9E11C478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429840" y="444600"/>
            <a:ext cx="5403960" cy="7484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689"/>
              </a:spcBef>
              <a:tabLst>
                <a:tab algn="l" pos="0"/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5743E8C-791C-4B85-B9BD-69885B99F0C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29840" y="444600"/>
            <a:ext cx="5403960" cy="161424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3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29840" y="2224080"/>
            <a:ext cx="2637000" cy="252756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3198960" y="2224080"/>
            <a:ext cx="2637000" cy="529920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429840" y="4992120"/>
            <a:ext cx="2637000" cy="252756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27DFD72-183D-4905-BB27-B69803EBAA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29840" y="444600"/>
            <a:ext cx="5403960" cy="161424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3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29840" y="2224080"/>
            <a:ext cx="5403960" cy="5299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689"/>
              </a:spcBef>
              <a:buNone/>
              <a:tabLst>
                <a:tab algn="l" pos="0"/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0E0032-E305-4525-BE94-0CE7B6AD26F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29840" y="444600"/>
            <a:ext cx="5403960" cy="161424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3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429840" y="2224080"/>
            <a:ext cx="2637000" cy="529920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3198960" y="2224080"/>
            <a:ext cx="2637000" cy="252756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3198960" y="4992120"/>
            <a:ext cx="2637000" cy="252756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A81E62E-4DD5-4E53-BC63-05E045156A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429840" y="444600"/>
            <a:ext cx="5403960" cy="161424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3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429840" y="2224080"/>
            <a:ext cx="2637000" cy="252756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3198960" y="2224080"/>
            <a:ext cx="2637000" cy="252756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429840" y="4992120"/>
            <a:ext cx="5403960" cy="252756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9CD52DD-05CE-47FC-857A-CBA4B47F31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29840" y="444600"/>
            <a:ext cx="5403960" cy="161424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3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429840" y="2224080"/>
            <a:ext cx="5403960" cy="252756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29840" y="4992120"/>
            <a:ext cx="5403960" cy="252756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04D09FF-09E2-49A1-BF36-2BB49E66ED7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429840" y="444600"/>
            <a:ext cx="5403960" cy="161424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3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429840" y="2224080"/>
            <a:ext cx="2637000" cy="252756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3198960" y="2224080"/>
            <a:ext cx="2637000" cy="252756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429840" y="4992120"/>
            <a:ext cx="2637000" cy="252756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3198960" y="4992120"/>
            <a:ext cx="2637000" cy="252756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5FE5B2C-A3A6-497B-9815-FD5730058F3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429840" y="444600"/>
            <a:ext cx="5403960" cy="161424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3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429840" y="2224080"/>
            <a:ext cx="1739880" cy="252756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2257200" y="2224080"/>
            <a:ext cx="1739880" cy="252756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4084200" y="2224080"/>
            <a:ext cx="1739880" cy="252756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29840" y="4992120"/>
            <a:ext cx="1739880" cy="252756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2257200" y="4992120"/>
            <a:ext cx="1739880" cy="252756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4084200" y="4992120"/>
            <a:ext cx="1739880" cy="252756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E5470E9-E6F9-4F2B-BA5F-F56BFDADD7E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29840" y="444600"/>
            <a:ext cx="5403960" cy="161424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3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29840" y="2224080"/>
            <a:ext cx="5403960" cy="529920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DC8538-611C-417D-8C86-8A276BF3AA0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29840" y="444600"/>
            <a:ext cx="5403960" cy="161424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3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29840" y="2224080"/>
            <a:ext cx="2637000" cy="529920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198960" y="2224080"/>
            <a:ext cx="2637000" cy="529920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66C31A-336B-46C8-A0A9-FD96728B9EC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29840" y="444600"/>
            <a:ext cx="5403960" cy="161424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3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A3D3F0-28EC-4899-8D2E-C73F288C984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29840" y="444600"/>
            <a:ext cx="5403960" cy="7484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689"/>
              </a:spcBef>
              <a:tabLst>
                <a:tab algn="l" pos="0"/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0A66DC-E0DC-4318-80C1-EF1DDD59B83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29840" y="444600"/>
            <a:ext cx="5403960" cy="161424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3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29840" y="2224080"/>
            <a:ext cx="2637000" cy="252756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198960" y="2224080"/>
            <a:ext cx="2637000" cy="529920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29840" y="4992120"/>
            <a:ext cx="2637000" cy="252756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1391F4-A822-4570-94D9-B653D54A04E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29840" y="444600"/>
            <a:ext cx="5403960" cy="161424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3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29840" y="2224080"/>
            <a:ext cx="2637000" cy="529920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198960" y="2224080"/>
            <a:ext cx="2637000" cy="252756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198960" y="4992120"/>
            <a:ext cx="2637000" cy="252756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E5B84F-78DC-4251-B956-1E265624037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29840" y="444600"/>
            <a:ext cx="5403960" cy="161424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3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29840" y="2224080"/>
            <a:ext cx="2637000" cy="252756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198960" y="2224080"/>
            <a:ext cx="2637000" cy="252756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29840" y="4992120"/>
            <a:ext cx="5403960" cy="252756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indent="0">
              <a:lnSpc>
                <a:spcPct val="90000"/>
              </a:lnSpc>
              <a:spcBef>
                <a:spcPts val="689"/>
              </a:spcBef>
              <a:buNone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A09377-A1C2-4326-BE49-B267559FCF4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29840" y="444600"/>
            <a:ext cx="5403960" cy="161424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29840" y="2224080"/>
            <a:ext cx="5403960" cy="529920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marL="155520" indent="-155520">
              <a:lnSpc>
                <a:spcPct val="90000"/>
              </a:lnSpc>
              <a:spcBef>
                <a:spcPts val="689"/>
              </a:spcBef>
              <a:buClr>
                <a:srgbClr val="000000"/>
              </a:buClr>
              <a:buFont typeface="Arial"/>
              <a:buChar char="•"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  <a:p>
            <a:pPr lvl="1" marL="468360" indent="-155520">
              <a:lnSpc>
                <a:spcPct val="90000"/>
              </a:lnSpc>
              <a:spcBef>
                <a:spcPts val="689"/>
              </a:spcBef>
              <a:buClr>
                <a:srgbClr val="000000"/>
              </a:buClr>
              <a:buFont typeface="Arial"/>
              <a:buChar char="•"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  <a:p>
            <a:pPr lvl="2" marL="782640" indent="-155520">
              <a:lnSpc>
                <a:spcPct val="90000"/>
              </a:lnSpc>
              <a:spcBef>
                <a:spcPts val="689"/>
              </a:spcBef>
              <a:buClr>
                <a:srgbClr val="000000"/>
              </a:buClr>
              <a:buFont typeface="Arial"/>
              <a:buChar char="•"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  <a:p>
            <a:pPr lvl="3" marL="1095480" indent="-155520">
              <a:lnSpc>
                <a:spcPct val="90000"/>
              </a:lnSpc>
              <a:spcBef>
                <a:spcPts val="689"/>
              </a:spcBef>
              <a:buClr>
                <a:srgbClr val="000000"/>
              </a:buClr>
              <a:buFont typeface="Arial"/>
              <a:buChar char="•"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  <a:p>
            <a:pPr lvl="4" marL="1407960" indent="-155520">
              <a:lnSpc>
                <a:spcPct val="90000"/>
              </a:lnSpc>
              <a:spcBef>
                <a:spcPts val="689"/>
              </a:spcBef>
              <a:buClr>
                <a:srgbClr val="000000"/>
              </a:buClr>
              <a:buFont typeface="Arial"/>
              <a:buChar char="•"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  <a:p>
            <a:pPr lvl="5" marL="1407960" indent="-155520">
              <a:lnSpc>
                <a:spcPct val="90000"/>
              </a:lnSpc>
              <a:spcBef>
                <a:spcPts val="689"/>
              </a:spcBef>
              <a:buClr>
                <a:srgbClr val="000000"/>
              </a:buClr>
              <a:buFont typeface="Arial"/>
              <a:buChar char="•"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  <a:p>
            <a:pPr lvl="6" marL="1407960" indent="-155520">
              <a:lnSpc>
                <a:spcPct val="90000"/>
              </a:lnSpc>
              <a:spcBef>
                <a:spcPts val="689"/>
              </a:spcBef>
              <a:buClr>
                <a:srgbClr val="000000"/>
              </a:buClr>
              <a:buFont typeface="Arial"/>
              <a:buChar char="•"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30200" y="7741800"/>
            <a:ext cx="1409760" cy="44460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ctr">
            <a:noAutofit/>
          </a:bodyPr>
          <a:lstStyle>
            <a:lvl1pPr indent="0">
              <a:buNone/>
              <a:tabLst>
                <a:tab algn="l" pos="0"/>
                <a:tab algn="l" pos="417600"/>
                <a:tab algn="l" pos="835200"/>
                <a:tab algn="l" pos="1252440"/>
                <a:tab algn="l" pos="1670040"/>
                <a:tab algn="l" pos="2087640"/>
                <a:tab algn="l" pos="2505240"/>
                <a:tab algn="l" pos="2922480"/>
                <a:tab algn="l" pos="3340080"/>
                <a:tab algn="l" pos="3757680"/>
                <a:tab algn="l" pos="4175280"/>
                <a:tab algn="l" pos="4592520"/>
                <a:tab algn="l" pos="5010120"/>
                <a:tab algn="l" pos="5427720"/>
                <a:tab algn="l" pos="5845320"/>
                <a:tab algn="l" pos="6262560"/>
                <a:tab algn="l" pos="6680160"/>
                <a:tab algn="l" pos="7097760"/>
                <a:tab algn="l" pos="7515360"/>
                <a:tab algn="l" pos="7932600"/>
                <a:tab algn="l" pos="8350200"/>
              </a:tabLst>
              <a:defRPr b="0" lang="zh-CN" sz="800" spc="-1" strike="noStrike">
                <a:solidFill>
                  <a:srgbClr val="898989"/>
                </a:solidFill>
                <a:latin typeface="Calibri"/>
                <a:ea typeface="等线"/>
              </a:defRPr>
            </a:lvl1pPr>
          </a:lstStyle>
          <a:p>
            <a:pPr indent="0">
              <a:buNone/>
              <a:tabLst>
                <a:tab algn="l" pos="0"/>
                <a:tab algn="l" pos="417600"/>
                <a:tab algn="l" pos="835200"/>
                <a:tab algn="l" pos="1252440"/>
                <a:tab algn="l" pos="1670040"/>
                <a:tab algn="l" pos="2087640"/>
                <a:tab algn="l" pos="2505240"/>
                <a:tab algn="l" pos="2922480"/>
                <a:tab algn="l" pos="3340080"/>
                <a:tab algn="l" pos="3757680"/>
                <a:tab algn="l" pos="4175280"/>
                <a:tab algn="l" pos="4592520"/>
                <a:tab algn="l" pos="5010120"/>
                <a:tab algn="l" pos="5427720"/>
                <a:tab algn="l" pos="5845320"/>
                <a:tab algn="l" pos="6262560"/>
                <a:tab algn="l" pos="6680160"/>
                <a:tab algn="l" pos="7097760"/>
                <a:tab algn="l" pos="7515360"/>
                <a:tab algn="l" pos="7932600"/>
                <a:tab algn="l" pos="8350200"/>
              </a:tabLst>
            </a:pPr>
            <a:r>
              <a:rPr b="0" lang="zh-CN" sz="800" spc="-1" strike="noStrike">
                <a:solidFill>
                  <a:srgbClr val="898989"/>
                </a:solidFill>
                <a:latin typeface="Calibri"/>
                <a:ea typeface="等线"/>
              </a:rPr>
              <a:t>&lt;date/time&gt;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074680" y="7741800"/>
            <a:ext cx="2114280" cy="44460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ctr">
            <a:noAutofit/>
          </a:bodyPr>
          <a:p>
            <a:pPr indent="0">
              <a:buNone/>
              <a:tabLst>
                <a:tab algn="l" pos="0"/>
                <a:tab algn="l" pos="417600"/>
                <a:tab algn="l" pos="835200"/>
                <a:tab algn="l" pos="1252440"/>
                <a:tab algn="l" pos="1670040"/>
                <a:tab algn="l" pos="2087640"/>
                <a:tab algn="l" pos="2505240"/>
                <a:tab algn="l" pos="2922480"/>
                <a:tab algn="l" pos="3340080"/>
                <a:tab algn="l" pos="3757680"/>
                <a:tab algn="l" pos="4175280"/>
                <a:tab algn="l" pos="4592520"/>
                <a:tab algn="l" pos="5010120"/>
                <a:tab algn="l" pos="5427720"/>
                <a:tab algn="l" pos="5845320"/>
                <a:tab algn="l" pos="6262560"/>
                <a:tab algn="l" pos="6680160"/>
                <a:tab algn="l" pos="7097760"/>
                <a:tab algn="l" pos="7515360"/>
                <a:tab algn="l" pos="7932600"/>
                <a:tab algn="l" pos="83502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424400" y="7741800"/>
            <a:ext cx="1409760" cy="44460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ctr">
            <a:noAutofit/>
          </a:bodyPr>
          <a:lstStyle>
            <a:lvl1pPr indent="0" algn="r">
              <a:buNone/>
              <a:tabLst>
                <a:tab algn="l" pos="0"/>
                <a:tab algn="l" pos="417600"/>
                <a:tab algn="l" pos="835200"/>
                <a:tab algn="l" pos="1252440"/>
                <a:tab algn="l" pos="1670040"/>
                <a:tab algn="l" pos="2087640"/>
                <a:tab algn="l" pos="2505240"/>
                <a:tab algn="l" pos="2922480"/>
                <a:tab algn="l" pos="3340080"/>
                <a:tab algn="l" pos="3757680"/>
                <a:tab algn="l" pos="4175280"/>
                <a:tab algn="l" pos="4592520"/>
                <a:tab algn="l" pos="5010120"/>
                <a:tab algn="l" pos="5427720"/>
                <a:tab algn="l" pos="5845320"/>
                <a:tab algn="l" pos="6262560"/>
                <a:tab algn="l" pos="6680160"/>
                <a:tab algn="l" pos="7097760"/>
                <a:tab algn="l" pos="7515360"/>
                <a:tab algn="l" pos="7932600"/>
                <a:tab algn="l" pos="8350200"/>
              </a:tabLst>
              <a:defRPr b="0" lang="zh-CN" sz="800" spc="-1" strike="noStrike">
                <a:solidFill>
                  <a:srgbClr val="898989"/>
                </a:solidFill>
                <a:latin typeface="Calibri"/>
                <a:ea typeface="等线"/>
              </a:defRPr>
            </a:lvl1pPr>
          </a:lstStyle>
          <a:p>
            <a:pPr indent="0" algn="r">
              <a:buNone/>
              <a:tabLst>
                <a:tab algn="l" pos="0"/>
                <a:tab algn="l" pos="417600"/>
                <a:tab algn="l" pos="835200"/>
                <a:tab algn="l" pos="1252440"/>
                <a:tab algn="l" pos="1670040"/>
                <a:tab algn="l" pos="2087640"/>
                <a:tab algn="l" pos="2505240"/>
                <a:tab algn="l" pos="2922480"/>
                <a:tab algn="l" pos="3340080"/>
                <a:tab algn="l" pos="3757680"/>
                <a:tab algn="l" pos="4175280"/>
                <a:tab algn="l" pos="4592520"/>
                <a:tab algn="l" pos="5010120"/>
                <a:tab algn="l" pos="5427720"/>
                <a:tab algn="l" pos="5845320"/>
                <a:tab algn="l" pos="6262560"/>
                <a:tab algn="l" pos="6680160"/>
                <a:tab algn="l" pos="7097760"/>
                <a:tab algn="l" pos="7515360"/>
                <a:tab algn="l" pos="7932600"/>
                <a:tab algn="l" pos="8350200"/>
              </a:tabLst>
            </a:pPr>
            <a:fld id="{D2AF2A74-A04D-43D2-A29C-A2B1DF6F50BE}" type="slidenum">
              <a:rPr b="0" lang="zh-CN" sz="800" spc="-1" strike="noStrike">
                <a:solidFill>
                  <a:srgbClr val="898989"/>
                </a:solidFill>
                <a:latin typeface="Calibri"/>
                <a:ea typeface="等线"/>
              </a:rPr>
              <a:t>&lt;number&gt;</a:t>
            </a:fld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29840" y="444600"/>
            <a:ext cx="5403960" cy="161424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0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429840" y="2224080"/>
            <a:ext cx="5403960" cy="529920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t">
            <a:normAutofit/>
          </a:bodyPr>
          <a:p>
            <a:pPr marL="155520" indent="-155520">
              <a:lnSpc>
                <a:spcPct val="90000"/>
              </a:lnSpc>
              <a:spcBef>
                <a:spcPts val="689"/>
              </a:spcBef>
              <a:buClr>
                <a:srgbClr val="000000"/>
              </a:buClr>
              <a:buFont typeface="Arial"/>
              <a:buChar char="•"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  <a:p>
            <a:pPr lvl="1" marL="468360" indent="-155520">
              <a:lnSpc>
                <a:spcPct val="90000"/>
              </a:lnSpc>
              <a:spcBef>
                <a:spcPts val="689"/>
              </a:spcBef>
              <a:buClr>
                <a:srgbClr val="000000"/>
              </a:buClr>
              <a:buFont typeface="Arial"/>
              <a:buChar char="•"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  <a:p>
            <a:pPr lvl="2" marL="782640" indent="-155520">
              <a:lnSpc>
                <a:spcPct val="90000"/>
              </a:lnSpc>
              <a:spcBef>
                <a:spcPts val="689"/>
              </a:spcBef>
              <a:buClr>
                <a:srgbClr val="000000"/>
              </a:buClr>
              <a:buFont typeface="Arial"/>
              <a:buChar char="•"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  <a:p>
            <a:pPr lvl="3" marL="1095480" indent="-155520">
              <a:lnSpc>
                <a:spcPct val="90000"/>
              </a:lnSpc>
              <a:spcBef>
                <a:spcPts val="689"/>
              </a:spcBef>
              <a:buClr>
                <a:srgbClr val="000000"/>
              </a:buClr>
              <a:buFont typeface="Arial"/>
              <a:buChar char="•"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  <a:p>
            <a:pPr lvl="4" marL="1407960" indent="-155520">
              <a:lnSpc>
                <a:spcPct val="90000"/>
              </a:lnSpc>
              <a:spcBef>
                <a:spcPts val="689"/>
              </a:spcBef>
              <a:buClr>
                <a:srgbClr val="000000"/>
              </a:buClr>
              <a:buFont typeface="Arial"/>
              <a:buChar char="•"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  <a:p>
            <a:pPr lvl="5" marL="1407960" indent="-155520">
              <a:lnSpc>
                <a:spcPct val="90000"/>
              </a:lnSpc>
              <a:spcBef>
                <a:spcPts val="689"/>
              </a:spcBef>
              <a:buClr>
                <a:srgbClr val="000000"/>
              </a:buClr>
              <a:buFont typeface="Arial"/>
              <a:buChar char="•"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  <a:p>
            <a:pPr lvl="6" marL="1407960" indent="-155520">
              <a:lnSpc>
                <a:spcPct val="90000"/>
              </a:lnSpc>
              <a:spcBef>
                <a:spcPts val="689"/>
              </a:spcBef>
              <a:buClr>
                <a:srgbClr val="000000"/>
              </a:buClr>
              <a:buFont typeface="Arial"/>
              <a:buChar char="•"/>
              <a:tabLst>
                <a:tab algn="l" pos="625320"/>
                <a:tab algn="l" pos="1251000"/>
                <a:tab algn="l" pos="1876320"/>
                <a:tab algn="l" pos="2502000"/>
                <a:tab algn="l" pos="3127320"/>
                <a:tab algn="l" pos="3753000"/>
                <a:tab algn="l" pos="4378320"/>
                <a:tab algn="l" pos="5003640"/>
                <a:tab algn="l" pos="5629320"/>
                <a:tab algn="l" pos="6254640"/>
                <a:tab algn="l" pos="6880320"/>
                <a:tab algn="l" pos="7505640"/>
                <a:tab algn="l" pos="8131320"/>
                <a:tab algn="l" pos="8756640"/>
                <a:tab algn="l" pos="9381960"/>
                <a:tab algn="l" pos="10007640"/>
                <a:tab algn="l" pos="1063296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430200" y="7741800"/>
            <a:ext cx="1409760" cy="44460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ctr">
            <a:noAutofit/>
          </a:bodyPr>
          <a:lstStyle>
            <a:lvl1pPr indent="0">
              <a:buNone/>
              <a:tabLst>
                <a:tab algn="l" pos="0"/>
                <a:tab algn="l" pos="417600"/>
                <a:tab algn="l" pos="835200"/>
                <a:tab algn="l" pos="1252440"/>
                <a:tab algn="l" pos="1670040"/>
                <a:tab algn="l" pos="2087640"/>
                <a:tab algn="l" pos="2505240"/>
                <a:tab algn="l" pos="2922480"/>
                <a:tab algn="l" pos="3340080"/>
                <a:tab algn="l" pos="3757680"/>
                <a:tab algn="l" pos="4175280"/>
                <a:tab algn="l" pos="4592520"/>
                <a:tab algn="l" pos="5010120"/>
                <a:tab algn="l" pos="5427720"/>
                <a:tab algn="l" pos="5845320"/>
                <a:tab algn="l" pos="6262560"/>
                <a:tab algn="l" pos="6680160"/>
                <a:tab algn="l" pos="7097760"/>
                <a:tab algn="l" pos="7515360"/>
                <a:tab algn="l" pos="7932600"/>
                <a:tab algn="l" pos="8350200"/>
              </a:tabLst>
              <a:defRPr b="0" lang="zh-CN" sz="800" spc="-1" strike="noStrike">
                <a:solidFill>
                  <a:srgbClr val="898989"/>
                </a:solidFill>
                <a:latin typeface="Calibri"/>
                <a:ea typeface="等线"/>
              </a:defRPr>
            </a:lvl1pPr>
          </a:lstStyle>
          <a:p>
            <a:pPr indent="0">
              <a:buNone/>
              <a:tabLst>
                <a:tab algn="l" pos="0"/>
                <a:tab algn="l" pos="417600"/>
                <a:tab algn="l" pos="835200"/>
                <a:tab algn="l" pos="1252440"/>
                <a:tab algn="l" pos="1670040"/>
                <a:tab algn="l" pos="2087640"/>
                <a:tab algn="l" pos="2505240"/>
                <a:tab algn="l" pos="2922480"/>
                <a:tab algn="l" pos="3340080"/>
                <a:tab algn="l" pos="3757680"/>
                <a:tab algn="l" pos="4175280"/>
                <a:tab algn="l" pos="4592520"/>
                <a:tab algn="l" pos="5010120"/>
                <a:tab algn="l" pos="5427720"/>
                <a:tab algn="l" pos="5845320"/>
                <a:tab algn="l" pos="6262560"/>
                <a:tab algn="l" pos="6680160"/>
                <a:tab algn="l" pos="7097760"/>
                <a:tab algn="l" pos="7515360"/>
                <a:tab algn="l" pos="7932600"/>
                <a:tab algn="l" pos="8350200"/>
              </a:tabLst>
            </a:pPr>
            <a:r>
              <a:rPr b="0" lang="zh-CN" sz="800" spc="-1" strike="noStrike">
                <a:solidFill>
                  <a:srgbClr val="898989"/>
                </a:solidFill>
                <a:latin typeface="Calibri"/>
                <a:ea typeface="等线"/>
              </a:rPr>
              <a:t>&lt;date/time&gt;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2074680" y="7741800"/>
            <a:ext cx="2114280" cy="44460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ctr">
            <a:noAutofit/>
          </a:bodyPr>
          <a:p>
            <a:pPr indent="0">
              <a:buNone/>
              <a:tabLst>
                <a:tab algn="l" pos="0"/>
                <a:tab algn="l" pos="417600"/>
                <a:tab algn="l" pos="835200"/>
                <a:tab algn="l" pos="1252440"/>
                <a:tab algn="l" pos="1670040"/>
                <a:tab algn="l" pos="2087640"/>
                <a:tab algn="l" pos="2505240"/>
                <a:tab algn="l" pos="2922480"/>
                <a:tab algn="l" pos="3340080"/>
                <a:tab algn="l" pos="3757680"/>
                <a:tab algn="l" pos="4175280"/>
                <a:tab algn="l" pos="4592520"/>
                <a:tab algn="l" pos="5010120"/>
                <a:tab algn="l" pos="5427720"/>
                <a:tab algn="l" pos="5845320"/>
                <a:tab algn="l" pos="6262560"/>
                <a:tab algn="l" pos="6680160"/>
                <a:tab algn="l" pos="7097760"/>
                <a:tab algn="l" pos="7515360"/>
                <a:tab algn="l" pos="7932600"/>
                <a:tab algn="l" pos="83502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4424400" y="7741800"/>
            <a:ext cx="1409760" cy="444600"/>
          </a:xfrm>
          <a:prstGeom prst="rect">
            <a:avLst/>
          </a:prstGeom>
          <a:noFill/>
          <a:ln w="0">
            <a:noFill/>
          </a:ln>
        </p:spPr>
        <p:txBody>
          <a:bodyPr lIns="83520" rIns="83520" tIns="41760" bIns="41760" anchor="ctr">
            <a:noAutofit/>
          </a:bodyPr>
          <a:lstStyle>
            <a:lvl1pPr indent="0" algn="r">
              <a:buNone/>
              <a:tabLst>
                <a:tab algn="l" pos="0"/>
                <a:tab algn="l" pos="417600"/>
                <a:tab algn="l" pos="835200"/>
                <a:tab algn="l" pos="1252440"/>
                <a:tab algn="l" pos="1670040"/>
                <a:tab algn="l" pos="2087640"/>
                <a:tab algn="l" pos="2505240"/>
                <a:tab algn="l" pos="2922480"/>
                <a:tab algn="l" pos="3340080"/>
                <a:tab algn="l" pos="3757680"/>
                <a:tab algn="l" pos="4175280"/>
                <a:tab algn="l" pos="4592520"/>
                <a:tab algn="l" pos="5010120"/>
                <a:tab algn="l" pos="5427720"/>
                <a:tab algn="l" pos="5845320"/>
                <a:tab algn="l" pos="6262560"/>
                <a:tab algn="l" pos="6680160"/>
                <a:tab algn="l" pos="7097760"/>
                <a:tab algn="l" pos="7515360"/>
                <a:tab algn="l" pos="7932600"/>
                <a:tab algn="l" pos="8350200"/>
              </a:tabLst>
              <a:defRPr b="0" lang="zh-CN" sz="800" spc="-1" strike="noStrike">
                <a:solidFill>
                  <a:srgbClr val="898989"/>
                </a:solidFill>
                <a:latin typeface="Calibri"/>
                <a:ea typeface="等线"/>
              </a:defRPr>
            </a:lvl1pPr>
          </a:lstStyle>
          <a:p>
            <a:pPr indent="0" algn="r">
              <a:buNone/>
              <a:tabLst>
                <a:tab algn="l" pos="0"/>
                <a:tab algn="l" pos="417600"/>
                <a:tab algn="l" pos="835200"/>
                <a:tab algn="l" pos="1252440"/>
                <a:tab algn="l" pos="1670040"/>
                <a:tab algn="l" pos="2087640"/>
                <a:tab algn="l" pos="2505240"/>
                <a:tab algn="l" pos="2922480"/>
                <a:tab algn="l" pos="3340080"/>
                <a:tab algn="l" pos="3757680"/>
                <a:tab algn="l" pos="4175280"/>
                <a:tab algn="l" pos="4592520"/>
                <a:tab algn="l" pos="5010120"/>
                <a:tab algn="l" pos="5427720"/>
                <a:tab algn="l" pos="5845320"/>
                <a:tab algn="l" pos="6262560"/>
                <a:tab algn="l" pos="6680160"/>
                <a:tab algn="l" pos="7097760"/>
                <a:tab algn="l" pos="7515360"/>
                <a:tab algn="l" pos="7932600"/>
                <a:tab algn="l" pos="8350200"/>
              </a:tabLst>
            </a:pPr>
            <a:fld id="{50F92BB1-5C86-4DD2-9AAD-ECABE4AF0DF7}" type="slidenum">
              <a:rPr b="0" lang="zh-CN" sz="800" spc="-1" strike="noStrike">
                <a:solidFill>
                  <a:srgbClr val="898989"/>
                </a:solidFill>
                <a:latin typeface="Calibri"/>
                <a:ea typeface="等线"/>
              </a:rPr>
              <a:t>&lt;number&gt;</a:t>
            </a:fld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文本框 17"/>
          <p:cNvSpPr/>
          <p:nvPr/>
        </p:nvSpPr>
        <p:spPr>
          <a:xfrm>
            <a:off x="371520" y="6048360"/>
            <a:ext cx="527508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35200"/>
                <a:tab algn="l" pos="1670040"/>
                <a:tab algn="l" pos="2505240"/>
                <a:tab algn="l" pos="3340080"/>
                <a:tab algn="l" pos="4175280"/>
                <a:tab algn="l" pos="5010120"/>
                <a:tab algn="l" pos="5845320"/>
                <a:tab algn="l" pos="6680160"/>
                <a:tab algn="l" pos="7515360"/>
                <a:tab algn="l" pos="8350200"/>
                <a:tab algn="l" pos="9185400"/>
                <a:tab algn="l" pos="10020240"/>
                <a:tab algn="l" pos="1085544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楷体"/>
              </a:rPr>
              <a:t>Supplemental figure 1.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  <a:ea typeface="楷体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Experimental design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(A) Folic acid-induced tubulointerstitial fibrosis in ICR mice. (B) circHIPK3 overexpressed in HK-2 cells. (C) TGF-β1 induced fibrosis in HK-2 cells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(D) The expression of  circHIPK3/miR-30a/ TGF-β1 in in renal biopsies of patients with chronic tubulointerstitial nephritis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文本框 123"/>
          <p:cNvSpPr/>
          <p:nvPr/>
        </p:nvSpPr>
        <p:spPr>
          <a:xfrm>
            <a:off x="371520" y="382680"/>
            <a:ext cx="4603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17600"/>
                <a:tab algn="l" pos="835200"/>
                <a:tab algn="l" pos="1252440"/>
                <a:tab algn="l" pos="1670040"/>
                <a:tab algn="l" pos="2087640"/>
                <a:tab algn="l" pos="2505240"/>
                <a:tab algn="l" pos="2922480"/>
                <a:tab algn="l" pos="3340080"/>
                <a:tab algn="l" pos="3757680"/>
                <a:tab algn="l" pos="4175280"/>
                <a:tab algn="l" pos="4592520"/>
                <a:tab algn="l" pos="5010120"/>
                <a:tab algn="l" pos="5427720"/>
                <a:tab algn="l" pos="5845320"/>
                <a:tab algn="l" pos="6262560"/>
                <a:tab algn="l" pos="6680160"/>
                <a:tab algn="l" pos="7097760"/>
                <a:tab algn="l" pos="7515360"/>
                <a:tab algn="l" pos="7932600"/>
                <a:tab algn="l" pos="83502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MS PGothic"/>
              </a:rPr>
              <a:t>A  Folic acid-induced tubulointerstitial fibrosis in ICR mice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4" name="Group 5"/>
          <p:cNvGrpSpPr/>
          <p:nvPr/>
        </p:nvGrpSpPr>
        <p:grpSpPr>
          <a:xfrm>
            <a:off x="442800" y="574560"/>
            <a:ext cx="5184720" cy="1275120"/>
            <a:chOff x="442800" y="574560"/>
            <a:chExt cx="5184720" cy="1275120"/>
          </a:xfrm>
        </p:grpSpPr>
        <p:sp>
          <p:nvSpPr>
            <p:cNvPr id="85" name="文本框 41"/>
            <p:cNvSpPr/>
            <p:nvPr/>
          </p:nvSpPr>
          <p:spPr>
            <a:xfrm>
              <a:off x="651600" y="1158840"/>
              <a:ext cx="1117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17600"/>
                  <a:tab algn="l" pos="835200"/>
                  <a:tab algn="l" pos="1252440"/>
                  <a:tab algn="l" pos="1670040"/>
                  <a:tab algn="l" pos="2087640"/>
                  <a:tab algn="l" pos="2505240"/>
                  <a:tab algn="l" pos="2922480"/>
                  <a:tab algn="l" pos="3340080"/>
                  <a:tab algn="l" pos="3757680"/>
                  <a:tab algn="l" pos="4175280"/>
                  <a:tab algn="l" pos="4592520"/>
                  <a:tab algn="l" pos="5010120"/>
                  <a:tab algn="l" pos="5427720"/>
                  <a:tab algn="l" pos="5845320"/>
                  <a:tab algn="l" pos="6262560"/>
                  <a:tab algn="l" pos="6680160"/>
                  <a:tab algn="l" pos="7097760"/>
                  <a:tab algn="l" pos="7515360"/>
                  <a:tab algn="l" pos="7932600"/>
                  <a:tab algn="l" pos="83502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Post FA injection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Rectangle 72"/>
            <p:cNvSpPr/>
            <p:nvPr/>
          </p:nvSpPr>
          <p:spPr>
            <a:xfrm>
              <a:off x="442800" y="979200"/>
              <a:ext cx="1224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17600"/>
                  <a:tab algn="l" pos="835200"/>
                  <a:tab algn="l" pos="1252440"/>
                  <a:tab algn="l" pos="1670040"/>
                  <a:tab algn="l" pos="2087640"/>
                  <a:tab algn="l" pos="2505240"/>
                  <a:tab algn="l" pos="2922480"/>
                  <a:tab algn="l" pos="3340080"/>
                  <a:tab algn="l" pos="3757680"/>
                  <a:tab algn="l" pos="4175280"/>
                  <a:tab algn="l" pos="4592520"/>
                  <a:tab algn="l" pos="5010120"/>
                  <a:tab algn="l" pos="5427720"/>
                  <a:tab algn="l" pos="5845320"/>
                  <a:tab algn="l" pos="6262560"/>
                  <a:tab algn="l" pos="6680160"/>
                  <a:tab algn="l" pos="7097760"/>
                  <a:tab algn="l" pos="7515360"/>
                  <a:tab algn="l" pos="7932600"/>
                  <a:tab algn="l" pos="83502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Male ICR mice (n=6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直接连接符 79"/>
            <p:cNvSpPr/>
            <p:nvPr/>
          </p:nvSpPr>
          <p:spPr>
            <a:xfrm>
              <a:off x="1712520" y="1079280"/>
              <a:ext cx="3370320" cy="158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直接连接符 80"/>
            <p:cNvSpPr/>
            <p:nvPr/>
          </p:nvSpPr>
          <p:spPr>
            <a:xfrm>
              <a:off x="1712520" y="934920"/>
              <a:ext cx="0" cy="2300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直接连接符 90"/>
            <p:cNvSpPr/>
            <p:nvPr/>
          </p:nvSpPr>
          <p:spPr>
            <a:xfrm>
              <a:off x="5095800" y="934920"/>
              <a:ext cx="0" cy="2300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文本框 1"/>
            <p:cNvSpPr/>
            <p:nvPr/>
          </p:nvSpPr>
          <p:spPr>
            <a:xfrm>
              <a:off x="1573920" y="574560"/>
              <a:ext cx="1032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17600"/>
                  <a:tab algn="l" pos="835200"/>
                  <a:tab algn="l" pos="1252440"/>
                  <a:tab algn="l" pos="1670040"/>
                  <a:tab algn="l" pos="2087640"/>
                  <a:tab algn="l" pos="2505240"/>
                  <a:tab algn="l" pos="2922480"/>
                  <a:tab algn="l" pos="3340080"/>
                  <a:tab algn="l" pos="3757680"/>
                  <a:tab algn="l" pos="4175280"/>
                  <a:tab algn="l" pos="4592520"/>
                  <a:tab algn="l" pos="5010120"/>
                  <a:tab algn="l" pos="5427720"/>
                  <a:tab algn="l" pos="5845320"/>
                  <a:tab algn="l" pos="6262560"/>
                  <a:tab algn="l" pos="6680160"/>
                  <a:tab algn="l" pos="7097760"/>
                  <a:tab algn="l" pos="7515360"/>
                  <a:tab algn="l" pos="7932600"/>
                  <a:tab algn="l" pos="83502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FA (250mg/kg, ip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文本框 2"/>
            <p:cNvSpPr/>
            <p:nvPr/>
          </p:nvSpPr>
          <p:spPr>
            <a:xfrm>
              <a:off x="1586160" y="1162080"/>
              <a:ext cx="371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17600"/>
                  <a:tab algn="l" pos="835200"/>
                  <a:tab algn="l" pos="1252440"/>
                  <a:tab algn="l" pos="1670040"/>
                  <a:tab algn="l" pos="2087640"/>
                  <a:tab algn="l" pos="2505240"/>
                  <a:tab algn="l" pos="2922480"/>
                  <a:tab algn="l" pos="3340080"/>
                  <a:tab algn="l" pos="3757680"/>
                  <a:tab algn="l" pos="4175280"/>
                  <a:tab algn="l" pos="4592520"/>
                  <a:tab algn="l" pos="5010120"/>
                  <a:tab algn="l" pos="5427720"/>
                  <a:tab algn="l" pos="5845320"/>
                  <a:tab algn="l" pos="6262560"/>
                  <a:tab algn="l" pos="6680160"/>
                  <a:tab algn="l" pos="7097760"/>
                  <a:tab algn="l" pos="7515360"/>
                  <a:tab algn="l" pos="7932600"/>
                  <a:tab algn="l" pos="83502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0                                                                                                                 30 d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文本框 110"/>
            <p:cNvSpPr/>
            <p:nvPr/>
          </p:nvSpPr>
          <p:spPr>
            <a:xfrm>
              <a:off x="442800" y="1512360"/>
              <a:ext cx="51847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17600"/>
                  <a:tab algn="l" pos="835200"/>
                  <a:tab algn="l" pos="1252440"/>
                  <a:tab algn="l" pos="1670040"/>
                  <a:tab algn="l" pos="2087640"/>
                  <a:tab algn="l" pos="2505240"/>
                  <a:tab algn="l" pos="2922480"/>
                  <a:tab algn="l" pos="3340080"/>
                  <a:tab algn="l" pos="3757680"/>
                  <a:tab algn="l" pos="4175280"/>
                  <a:tab algn="l" pos="4592520"/>
                  <a:tab algn="l" pos="5010120"/>
                  <a:tab algn="l" pos="5427720"/>
                  <a:tab algn="l" pos="5845320"/>
                  <a:tab algn="l" pos="6262560"/>
                  <a:tab algn="l" pos="6680160"/>
                  <a:tab algn="l" pos="7097760"/>
                  <a:tab algn="l" pos="7515360"/>
                  <a:tab algn="l" pos="7932600"/>
                  <a:tab algn="l" pos="83502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Sample collection                                                                                                                           Tissue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17600"/>
                  <a:tab algn="l" pos="835200"/>
                  <a:tab algn="l" pos="1252440"/>
                  <a:tab algn="l" pos="1670040"/>
                  <a:tab algn="l" pos="2087640"/>
                  <a:tab algn="l" pos="2505240"/>
                  <a:tab algn="l" pos="2922480"/>
                  <a:tab algn="l" pos="3340080"/>
                  <a:tab algn="l" pos="3757680"/>
                  <a:tab algn="l" pos="4175280"/>
                  <a:tab algn="l" pos="4592520"/>
                  <a:tab algn="l" pos="5010120"/>
                  <a:tab algn="l" pos="5427720"/>
                  <a:tab algn="l" pos="5845320"/>
                  <a:tab algn="l" pos="6262560"/>
                  <a:tab algn="l" pos="6680160"/>
                  <a:tab algn="l" pos="7097760"/>
                  <a:tab algn="l" pos="7515360"/>
                  <a:tab algn="l" pos="7932600"/>
                  <a:tab algn="l" pos="83502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下箭头 130"/>
            <p:cNvSpPr/>
            <p:nvPr/>
          </p:nvSpPr>
          <p:spPr>
            <a:xfrm>
              <a:off x="1712520" y="790200"/>
              <a:ext cx="31680" cy="114120"/>
            </a:xfrm>
            <a:prstGeom prst="downArrow">
              <a:avLst>
                <a:gd name="adj1" fmla="val 50000"/>
                <a:gd name="adj2" fmla="val 50082"/>
              </a:avLst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17600"/>
                  <a:tab algn="l" pos="835200"/>
                  <a:tab algn="l" pos="1252440"/>
                  <a:tab algn="l" pos="1670040"/>
                  <a:tab algn="l" pos="2087640"/>
                  <a:tab algn="l" pos="2505240"/>
                  <a:tab algn="l" pos="2922480"/>
                  <a:tab algn="l" pos="3340080"/>
                  <a:tab algn="l" pos="3757680"/>
                  <a:tab algn="l" pos="4175280"/>
                  <a:tab algn="l" pos="4592520"/>
                  <a:tab algn="l" pos="5010120"/>
                  <a:tab algn="l" pos="5427720"/>
                  <a:tab algn="l" pos="5845320"/>
                  <a:tab algn="l" pos="6262560"/>
                  <a:tab algn="l" pos="6680160"/>
                  <a:tab algn="l" pos="7097760"/>
                  <a:tab algn="l" pos="7515360"/>
                  <a:tab algn="l" pos="7932600"/>
                  <a:tab algn="l" pos="83502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94" name="下箭头 97"/>
          <p:cNvSpPr/>
          <p:nvPr/>
        </p:nvSpPr>
        <p:spPr>
          <a:xfrm>
            <a:off x="5094360" y="1366920"/>
            <a:ext cx="30240" cy="114120"/>
          </a:xfrm>
          <a:prstGeom prst="downArrow">
            <a:avLst>
              <a:gd name="adj1" fmla="val 50000"/>
              <a:gd name="adj2" fmla="val 49793"/>
            </a:avLst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17600"/>
                <a:tab algn="l" pos="835200"/>
                <a:tab algn="l" pos="1252440"/>
                <a:tab algn="l" pos="1670040"/>
                <a:tab algn="l" pos="2087640"/>
                <a:tab algn="l" pos="2505240"/>
                <a:tab algn="l" pos="2922480"/>
                <a:tab algn="l" pos="3340080"/>
                <a:tab algn="l" pos="3757680"/>
                <a:tab algn="l" pos="4175280"/>
                <a:tab algn="l" pos="4592520"/>
                <a:tab algn="l" pos="5010120"/>
                <a:tab algn="l" pos="5427720"/>
                <a:tab algn="l" pos="5845320"/>
                <a:tab algn="l" pos="6262560"/>
                <a:tab algn="l" pos="6680160"/>
                <a:tab algn="l" pos="7097760"/>
                <a:tab algn="l" pos="7515360"/>
                <a:tab algn="l" pos="7932600"/>
                <a:tab algn="l" pos="83502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95" name="组合 11"/>
          <p:cNvGrpSpPr/>
          <p:nvPr/>
        </p:nvGrpSpPr>
        <p:grpSpPr>
          <a:xfrm>
            <a:off x="442800" y="5094360"/>
            <a:ext cx="4604040" cy="1022400"/>
            <a:chOff x="442800" y="5094360"/>
            <a:chExt cx="4604040" cy="1022400"/>
          </a:xfrm>
        </p:grpSpPr>
        <p:sp>
          <p:nvSpPr>
            <p:cNvPr id="96" name="文本框 123"/>
            <p:cNvSpPr/>
            <p:nvPr/>
          </p:nvSpPr>
          <p:spPr>
            <a:xfrm>
              <a:off x="442800" y="5094360"/>
              <a:ext cx="4604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17600"/>
                  <a:tab algn="l" pos="835200"/>
                  <a:tab algn="l" pos="1252440"/>
                  <a:tab algn="l" pos="1670040"/>
                  <a:tab algn="l" pos="2087640"/>
                  <a:tab algn="l" pos="2505240"/>
                  <a:tab algn="l" pos="2922480"/>
                  <a:tab algn="l" pos="3340080"/>
                  <a:tab algn="l" pos="3757680"/>
                  <a:tab algn="l" pos="4175280"/>
                  <a:tab algn="l" pos="4592520"/>
                  <a:tab algn="l" pos="5010120"/>
                  <a:tab algn="l" pos="5427720"/>
                  <a:tab algn="l" pos="5845320"/>
                  <a:tab algn="l" pos="6262560"/>
                  <a:tab algn="l" pos="6680160"/>
                  <a:tab algn="l" pos="7097760"/>
                  <a:tab algn="l" pos="7515360"/>
                  <a:tab algn="l" pos="7932600"/>
                  <a:tab algn="l" pos="83502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D The expression of  circHIPK3/miR-30a/ TGF-β1 in kidney tissue from human subject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97" name="直接箭头连接符 5"/>
            <p:cNvCxnSpPr/>
            <p:nvPr/>
          </p:nvCxnSpPr>
          <p:spPr>
            <a:xfrm>
              <a:off x="3984840" y="5201640"/>
              <a:ext cx="915120" cy="915480"/>
            </a:xfrm>
            <a:prstGeom prst="straightConnector1">
              <a:avLst/>
            </a:prstGeom>
            <a:ln w="15120">
              <a:solidFill>
                <a:srgbClr val="ffffff"/>
              </a:solidFill>
              <a:miter/>
              <a:tailEnd len="med" type="triangle" w="med"/>
            </a:ln>
          </p:spPr>
        </p:cxnSp>
      </p:grpSp>
      <p:grpSp>
        <p:nvGrpSpPr>
          <p:cNvPr id="98" name="组合 52"/>
          <p:cNvGrpSpPr/>
          <p:nvPr/>
        </p:nvGrpSpPr>
        <p:grpSpPr>
          <a:xfrm>
            <a:off x="404640" y="2117880"/>
            <a:ext cx="4712040" cy="1022400"/>
            <a:chOff x="404640" y="2117880"/>
            <a:chExt cx="4712040" cy="1022400"/>
          </a:xfrm>
        </p:grpSpPr>
        <p:sp>
          <p:nvSpPr>
            <p:cNvPr id="99" name="文本框 123"/>
            <p:cNvSpPr/>
            <p:nvPr/>
          </p:nvSpPr>
          <p:spPr>
            <a:xfrm>
              <a:off x="404640" y="2117880"/>
              <a:ext cx="4604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17600"/>
                  <a:tab algn="l" pos="835200"/>
                  <a:tab algn="l" pos="1252440"/>
                  <a:tab algn="l" pos="1670040"/>
                  <a:tab algn="l" pos="2087640"/>
                  <a:tab algn="l" pos="2505240"/>
                  <a:tab algn="l" pos="2922480"/>
                  <a:tab algn="l" pos="3340080"/>
                  <a:tab algn="l" pos="3757680"/>
                  <a:tab algn="l" pos="4175280"/>
                  <a:tab algn="l" pos="4592520"/>
                  <a:tab algn="l" pos="5010120"/>
                  <a:tab algn="l" pos="5427720"/>
                  <a:tab algn="l" pos="5845320"/>
                  <a:tab algn="l" pos="6262560"/>
                  <a:tab algn="l" pos="6680160"/>
                  <a:tab algn="l" pos="7097760"/>
                  <a:tab algn="l" pos="7515360"/>
                  <a:tab algn="l" pos="7932600"/>
                  <a:tab algn="l" pos="83502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B  circHIPK3 overexpressed in HK-2 cell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文本框 23"/>
            <p:cNvSpPr/>
            <p:nvPr/>
          </p:nvSpPr>
          <p:spPr>
            <a:xfrm>
              <a:off x="573840" y="2576880"/>
              <a:ext cx="1798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17600"/>
                  <a:tab algn="l" pos="835200"/>
                  <a:tab algn="l" pos="1252440"/>
                  <a:tab algn="l" pos="1670040"/>
                  <a:tab algn="l" pos="2087640"/>
                  <a:tab algn="l" pos="2505240"/>
                  <a:tab algn="l" pos="2922480"/>
                  <a:tab algn="l" pos="3340080"/>
                  <a:tab algn="l" pos="3757680"/>
                  <a:tab algn="l" pos="4175280"/>
                  <a:tab algn="l" pos="4592520"/>
                  <a:tab algn="l" pos="5010120"/>
                  <a:tab algn="l" pos="5427720"/>
                  <a:tab algn="l" pos="5845320"/>
                  <a:tab algn="l" pos="6262560"/>
                  <a:tab algn="l" pos="6680160"/>
                  <a:tab algn="l" pos="7097760"/>
                  <a:tab algn="l" pos="7515360"/>
                  <a:tab algn="l" pos="7932600"/>
                  <a:tab algn="l" pos="83502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HK-2 cells + Scrambled N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文本框 23"/>
            <p:cNvSpPr/>
            <p:nvPr/>
          </p:nvSpPr>
          <p:spPr>
            <a:xfrm>
              <a:off x="573840" y="2819880"/>
              <a:ext cx="1798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17600"/>
                  <a:tab algn="l" pos="835200"/>
                  <a:tab algn="l" pos="1252440"/>
                  <a:tab algn="l" pos="1670040"/>
                  <a:tab algn="l" pos="2087640"/>
                  <a:tab algn="l" pos="2505240"/>
                  <a:tab algn="l" pos="2922480"/>
                  <a:tab algn="l" pos="3340080"/>
                  <a:tab algn="l" pos="3757680"/>
                  <a:tab algn="l" pos="4175280"/>
                  <a:tab algn="l" pos="4592520"/>
                  <a:tab algn="l" pos="5010120"/>
                  <a:tab algn="l" pos="5427720"/>
                  <a:tab algn="l" pos="5845320"/>
                  <a:tab algn="l" pos="6262560"/>
                  <a:tab algn="l" pos="6680160"/>
                  <a:tab algn="l" pos="7097760"/>
                  <a:tab algn="l" pos="7515360"/>
                  <a:tab algn="l" pos="7932600"/>
                  <a:tab algn="l" pos="83502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HK-2 cells + circHIPK3 OE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102" name="直接箭头连接符 56"/>
            <p:cNvCxnSpPr/>
            <p:nvPr/>
          </p:nvCxnSpPr>
          <p:spPr>
            <a:xfrm>
              <a:off x="3946680" y="2225520"/>
              <a:ext cx="915120" cy="915120"/>
            </a:xfrm>
            <a:prstGeom prst="straightConnector1">
              <a:avLst/>
            </a:prstGeom>
            <a:ln w="15120">
              <a:solidFill>
                <a:srgbClr val="ffffff"/>
              </a:solidFill>
              <a:miter/>
              <a:tailEnd len="med" type="triangle" w="med"/>
            </a:ln>
          </p:spPr>
        </p:cxnSp>
        <p:cxnSp>
          <p:nvCxnSpPr>
            <p:cNvPr id="103" name="直接箭头连接符 57"/>
            <p:cNvCxnSpPr/>
            <p:nvPr/>
          </p:nvCxnSpPr>
          <p:spPr>
            <a:xfrm>
              <a:off x="2074680" y="2831760"/>
              <a:ext cx="310320" cy="1080"/>
            </a:xfrm>
            <a:prstGeom prst="straightConnector1">
              <a:avLst/>
            </a:prstGeom>
            <a:ln w="1512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104" name="文本框 23"/>
            <p:cNvSpPr/>
            <p:nvPr/>
          </p:nvSpPr>
          <p:spPr>
            <a:xfrm>
              <a:off x="2383920" y="2724120"/>
              <a:ext cx="1798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17600"/>
                  <a:tab algn="l" pos="835200"/>
                  <a:tab algn="l" pos="1252440"/>
                  <a:tab algn="l" pos="1670040"/>
                  <a:tab algn="l" pos="2087640"/>
                  <a:tab algn="l" pos="2505240"/>
                  <a:tab algn="l" pos="2922480"/>
                  <a:tab algn="l" pos="3340080"/>
                  <a:tab algn="l" pos="3757680"/>
                  <a:tab algn="l" pos="4175280"/>
                  <a:tab algn="l" pos="4592520"/>
                  <a:tab algn="l" pos="5010120"/>
                  <a:tab algn="l" pos="5427720"/>
                  <a:tab algn="l" pos="5845320"/>
                  <a:tab algn="l" pos="6262560"/>
                  <a:tab algn="l" pos="6680160"/>
                  <a:tab algn="l" pos="7097760"/>
                  <a:tab algn="l" pos="7515360"/>
                  <a:tab algn="l" pos="7932600"/>
                  <a:tab algn="l" pos="83502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Post 48 h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105" name="直接箭头连接符 59"/>
            <p:cNvCxnSpPr/>
            <p:nvPr/>
          </p:nvCxnSpPr>
          <p:spPr>
            <a:xfrm>
              <a:off x="3043080" y="2831760"/>
              <a:ext cx="308520" cy="1080"/>
            </a:xfrm>
            <a:prstGeom prst="straightConnector1">
              <a:avLst/>
            </a:prstGeom>
            <a:ln w="1512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106" name="文本框 23"/>
            <p:cNvSpPr/>
            <p:nvPr/>
          </p:nvSpPr>
          <p:spPr>
            <a:xfrm>
              <a:off x="3317760" y="2724120"/>
              <a:ext cx="1798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17600"/>
                  <a:tab algn="l" pos="835200"/>
                  <a:tab algn="l" pos="1252440"/>
                  <a:tab algn="l" pos="1670040"/>
                  <a:tab algn="l" pos="2087640"/>
                  <a:tab algn="l" pos="2505240"/>
                  <a:tab algn="l" pos="2922480"/>
                  <a:tab algn="l" pos="3340080"/>
                  <a:tab algn="l" pos="3757680"/>
                  <a:tab algn="l" pos="4175280"/>
                  <a:tab algn="l" pos="4592520"/>
                  <a:tab algn="l" pos="5010120"/>
                  <a:tab algn="l" pos="5427720"/>
                  <a:tab algn="l" pos="5845320"/>
                  <a:tab algn="l" pos="6262560"/>
                  <a:tab algn="l" pos="6680160"/>
                  <a:tab algn="l" pos="7097760"/>
                  <a:tab algn="l" pos="7515360"/>
                  <a:tab algn="l" pos="7932600"/>
                  <a:tab algn="l" pos="83502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Cells collectio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07" name="组合 61"/>
          <p:cNvGrpSpPr/>
          <p:nvPr/>
        </p:nvGrpSpPr>
        <p:grpSpPr>
          <a:xfrm>
            <a:off x="404640" y="3637080"/>
            <a:ext cx="4712040" cy="1022400"/>
            <a:chOff x="404640" y="3637080"/>
            <a:chExt cx="4712040" cy="1022400"/>
          </a:xfrm>
        </p:grpSpPr>
        <p:sp>
          <p:nvSpPr>
            <p:cNvPr id="108" name="文本框 123"/>
            <p:cNvSpPr/>
            <p:nvPr/>
          </p:nvSpPr>
          <p:spPr>
            <a:xfrm>
              <a:off x="404640" y="3637080"/>
              <a:ext cx="4604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17600"/>
                  <a:tab algn="l" pos="835200"/>
                  <a:tab algn="l" pos="1252440"/>
                  <a:tab algn="l" pos="1670040"/>
                  <a:tab algn="l" pos="2087640"/>
                  <a:tab algn="l" pos="2505240"/>
                  <a:tab algn="l" pos="2922480"/>
                  <a:tab algn="l" pos="3340080"/>
                  <a:tab algn="l" pos="3757680"/>
                  <a:tab algn="l" pos="4175280"/>
                  <a:tab algn="l" pos="4592520"/>
                  <a:tab algn="l" pos="5010120"/>
                  <a:tab algn="l" pos="5427720"/>
                  <a:tab algn="l" pos="5845320"/>
                  <a:tab algn="l" pos="6262560"/>
                  <a:tab algn="l" pos="6680160"/>
                  <a:tab algn="l" pos="7097760"/>
                  <a:tab algn="l" pos="7515360"/>
                  <a:tab algn="l" pos="7932600"/>
                  <a:tab algn="l" pos="83502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C  TGF-β1 induced fibrosis in HK-2 cell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文本框 23"/>
            <p:cNvSpPr/>
            <p:nvPr/>
          </p:nvSpPr>
          <p:spPr>
            <a:xfrm>
              <a:off x="573840" y="4096080"/>
              <a:ext cx="1798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17600"/>
                  <a:tab algn="l" pos="835200"/>
                  <a:tab algn="l" pos="1252440"/>
                  <a:tab algn="l" pos="1670040"/>
                  <a:tab algn="l" pos="2087640"/>
                  <a:tab algn="l" pos="2505240"/>
                  <a:tab algn="l" pos="2922480"/>
                  <a:tab algn="l" pos="3340080"/>
                  <a:tab algn="l" pos="3757680"/>
                  <a:tab algn="l" pos="4175280"/>
                  <a:tab algn="l" pos="4592520"/>
                  <a:tab algn="l" pos="5010120"/>
                  <a:tab algn="l" pos="5427720"/>
                  <a:tab algn="l" pos="5845320"/>
                  <a:tab algn="l" pos="6262560"/>
                  <a:tab algn="l" pos="6680160"/>
                  <a:tab algn="l" pos="7097760"/>
                  <a:tab algn="l" pos="7515360"/>
                  <a:tab algn="l" pos="7932600"/>
                  <a:tab algn="l" pos="83502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HK-2 cells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文本框 23"/>
            <p:cNvSpPr/>
            <p:nvPr/>
          </p:nvSpPr>
          <p:spPr>
            <a:xfrm>
              <a:off x="573840" y="4339440"/>
              <a:ext cx="1798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17600"/>
                  <a:tab algn="l" pos="835200"/>
                  <a:tab algn="l" pos="1252440"/>
                  <a:tab algn="l" pos="1670040"/>
                  <a:tab algn="l" pos="2087640"/>
                  <a:tab algn="l" pos="2505240"/>
                  <a:tab algn="l" pos="2922480"/>
                  <a:tab algn="l" pos="3340080"/>
                  <a:tab algn="l" pos="3757680"/>
                  <a:tab algn="l" pos="4175280"/>
                  <a:tab algn="l" pos="4592520"/>
                  <a:tab algn="l" pos="5010120"/>
                  <a:tab algn="l" pos="5427720"/>
                  <a:tab algn="l" pos="5845320"/>
                  <a:tab algn="l" pos="6262560"/>
                  <a:tab algn="l" pos="6680160"/>
                  <a:tab algn="l" pos="7097760"/>
                  <a:tab algn="l" pos="7515360"/>
                  <a:tab algn="l" pos="7932600"/>
                  <a:tab algn="l" pos="83502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HK-2 cells + TGF-β1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111" name="直接箭头连接符 65"/>
            <p:cNvCxnSpPr/>
            <p:nvPr/>
          </p:nvCxnSpPr>
          <p:spPr>
            <a:xfrm>
              <a:off x="3946680" y="3744360"/>
              <a:ext cx="915120" cy="915480"/>
            </a:xfrm>
            <a:prstGeom prst="straightConnector1">
              <a:avLst/>
            </a:prstGeom>
            <a:ln w="15120">
              <a:solidFill>
                <a:srgbClr val="ffffff"/>
              </a:solidFill>
              <a:miter/>
              <a:tailEnd len="med" type="triangle" w="med"/>
            </a:ln>
          </p:spPr>
        </p:cxnSp>
        <p:cxnSp>
          <p:nvCxnSpPr>
            <p:cNvPr id="112" name="直接箭头连接符 66"/>
            <p:cNvCxnSpPr/>
            <p:nvPr/>
          </p:nvCxnSpPr>
          <p:spPr>
            <a:xfrm>
              <a:off x="2074680" y="4351320"/>
              <a:ext cx="310320" cy="1080"/>
            </a:xfrm>
            <a:prstGeom prst="straightConnector1">
              <a:avLst/>
            </a:prstGeom>
            <a:ln w="1512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113" name="文本框 23"/>
            <p:cNvSpPr/>
            <p:nvPr/>
          </p:nvSpPr>
          <p:spPr>
            <a:xfrm>
              <a:off x="2383920" y="4243320"/>
              <a:ext cx="1798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17600"/>
                  <a:tab algn="l" pos="835200"/>
                  <a:tab algn="l" pos="1252440"/>
                  <a:tab algn="l" pos="1670040"/>
                  <a:tab algn="l" pos="2087640"/>
                  <a:tab algn="l" pos="2505240"/>
                  <a:tab algn="l" pos="2922480"/>
                  <a:tab algn="l" pos="3340080"/>
                  <a:tab algn="l" pos="3757680"/>
                  <a:tab algn="l" pos="4175280"/>
                  <a:tab algn="l" pos="4592520"/>
                  <a:tab algn="l" pos="5010120"/>
                  <a:tab algn="l" pos="5427720"/>
                  <a:tab algn="l" pos="5845320"/>
                  <a:tab algn="l" pos="6262560"/>
                  <a:tab algn="l" pos="6680160"/>
                  <a:tab algn="l" pos="7097760"/>
                  <a:tab algn="l" pos="7515360"/>
                  <a:tab algn="l" pos="7932600"/>
                  <a:tab algn="l" pos="83502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Post 48 h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114" name="直接箭头连接符 68"/>
            <p:cNvCxnSpPr/>
            <p:nvPr/>
          </p:nvCxnSpPr>
          <p:spPr>
            <a:xfrm>
              <a:off x="3043080" y="4351320"/>
              <a:ext cx="308520" cy="1080"/>
            </a:xfrm>
            <a:prstGeom prst="straightConnector1">
              <a:avLst/>
            </a:prstGeom>
            <a:ln w="1512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115" name="文本框 23"/>
            <p:cNvSpPr/>
            <p:nvPr/>
          </p:nvSpPr>
          <p:spPr>
            <a:xfrm>
              <a:off x="3317760" y="4243320"/>
              <a:ext cx="1798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17600"/>
                  <a:tab algn="l" pos="835200"/>
                  <a:tab algn="l" pos="1252440"/>
                  <a:tab algn="l" pos="1670040"/>
                  <a:tab algn="l" pos="2087640"/>
                  <a:tab algn="l" pos="2505240"/>
                  <a:tab algn="l" pos="2922480"/>
                  <a:tab algn="l" pos="3340080"/>
                  <a:tab algn="l" pos="3757680"/>
                  <a:tab algn="l" pos="4175280"/>
                  <a:tab algn="l" pos="4592520"/>
                  <a:tab algn="l" pos="5010120"/>
                  <a:tab algn="l" pos="5427720"/>
                  <a:tab algn="l" pos="5845320"/>
                  <a:tab algn="l" pos="6262560"/>
                  <a:tab algn="l" pos="6680160"/>
                  <a:tab algn="l" pos="7097760"/>
                  <a:tab algn="l" pos="7515360"/>
                  <a:tab algn="l" pos="7932600"/>
                  <a:tab algn="l" pos="83502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Cells collectio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16" name="Rectangle 1"/>
          <p:cNvSpPr/>
          <p:nvPr/>
        </p:nvSpPr>
        <p:spPr>
          <a:xfrm>
            <a:off x="595440" y="5483160"/>
            <a:ext cx="46468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171360" indent="-171360"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417600"/>
                <a:tab algn="l" pos="835200"/>
                <a:tab algn="l" pos="1252440"/>
                <a:tab algn="l" pos="1670040"/>
                <a:tab algn="l" pos="2087640"/>
                <a:tab algn="l" pos="2505240"/>
                <a:tab algn="l" pos="2922480"/>
                <a:tab algn="l" pos="3340080"/>
                <a:tab algn="l" pos="3757680"/>
                <a:tab algn="l" pos="4175280"/>
                <a:tab algn="l" pos="4592520"/>
                <a:tab algn="l" pos="5010120"/>
                <a:tab algn="l" pos="5427720"/>
                <a:tab algn="l" pos="5845320"/>
                <a:tab algn="l" pos="6262560"/>
                <a:tab algn="l" pos="6680160"/>
                <a:tab algn="l" pos="7097760"/>
                <a:tab algn="l" pos="7515360"/>
                <a:tab algn="l" pos="7932600"/>
                <a:tab algn="l" pos="83502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MS PGothic"/>
              </a:rPr>
              <a:t>Normal control kidney tissue: patients with renal tumor, tissue 5 cm far from the tumor   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171360" indent="-171360"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417600"/>
                <a:tab algn="l" pos="835200"/>
                <a:tab algn="l" pos="1252440"/>
                <a:tab algn="l" pos="1670040"/>
                <a:tab algn="l" pos="2087640"/>
                <a:tab algn="l" pos="2505240"/>
                <a:tab algn="l" pos="2922480"/>
                <a:tab algn="l" pos="3340080"/>
                <a:tab algn="l" pos="3757680"/>
                <a:tab algn="l" pos="4175280"/>
                <a:tab algn="l" pos="4592520"/>
                <a:tab algn="l" pos="5010120"/>
                <a:tab algn="l" pos="5427720"/>
                <a:tab algn="l" pos="5845320"/>
                <a:tab algn="l" pos="6262560"/>
                <a:tab algn="l" pos="6680160"/>
                <a:tab algn="l" pos="7097760"/>
                <a:tab algn="l" pos="7515360"/>
                <a:tab algn="l" pos="7932600"/>
                <a:tab algn="l" pos="8350200"/>
              </a:tabLst>
            </a:pP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171360" indent="-171360"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417600"/>
                <a:tab algn="l" pos="835200"/>
                <a:tab algn="l" pos="1252440"/>
                <a:tab algn="l" pos="1670040"/>
                <a:tab algn="l" pos="2087640"/>
                <a:tab algn="l" pos="2505240"/>
                <a:tab algn="l" pos="2922480"/>
                <a:tab algn="l" pos="3340080"/>
                <a:tab algn="l" pos="3757680"/>
                <a:tab algn="l" pos="4175280"/>
                <a:tab algn="l" pos="4592520"/>
                <a:tab algn="l" pos="5010120"/>
                <a:tab algn="l" pos="5427720"/>
                <a:tab algn="l" pos="5845320"/>
                <a:tab algn="l" pos="6262560"/>
                <a:tab algn="l" pos="6680160"/>
                <a:tab algn="l" pos="7097760"/>
                <a:tab algn="l" pos="7515360"/>
                <a:tab algn="l" pos="7932600"/>
                <a:tab algn="l" pos="83502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MS PGothic"/>
              </a:rPr>
              <a:t>Renal fibrosis: patients with chronic tubulointerstitial nephritis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矩形 1"/>
          <p:cNvSpPr/>
          <p:nvPr/>
        </p:nvSpPr>
        <p:spPr>
          <a:xfrm>
            <a:off x="246240" y="627120"/>
            <a:ext cx="5638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17600"/>
                <a:tab algn="l" pos="835200"/>
                <a:tab algn="l" pos="1252440"/>
                <a:tab algn="l" pos="1670040"/>
                <a:tab algn="l" pos="2087640"/>
                <a:tab algn="l" pos="2505240"/>
                <a:tab algn="l" pos="2922480"/>
                <a:tab algn="l" pos="3340080"/>
                <a:tab algn="l" pos="3757680"/>
                <a:tab algn="l" pos="4175280"/>
                <a:tab algn="l" pos="4592520"/>
                <a:tab algn="l" pos="5010120"/>
                <a:tab algn="l" pos="5427720"/>
                <a:tab algn="l" pos="5845320"/>
                <a:tab algn="l" pos="6262560"/>
                <a:tab algn="l" pos="6680160"/>
                <a:tab algn="l" pos="7097760"/>
                <a:tab algn="l" pos="7515360"/>
                <a:tab algn="l" pos="7932600"/>
                <a:tab algn="l" pos="83502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等线"/>
              </a:rPr>
              <a:t>Supplemental Table 1.  Antibodies used in immunoblotting and Immunofluorescence 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18" name=""/>
          <p:cNvGraphicFramePr/>
          <p:nvPr/>
        </p:nvGraphicFramePr>
        <p:xfrm>
          <a:off x="353880" y="843120"/>
          <a:ext cx="5537160" cy="4335480"/>
        </p:xfrm>
        <a:graphic>
          <a:graphicData uri="http://schemas.openxmlformats.org/drawingml/2006/table">
            <a:tbl>
              <a:tblPr/>
              <a:tblGrid>
                <a:gridCol w="1190880"/>
                <a:gridCol w="1471320"/>
                <a:gridCol w="830520"/>
                <a:gridCol w="609480"/>
                <a:gridCol w="673200"/>
                <a:gridCol w="761760"/>
              </a:tblGrid>
              <a:tr h="39672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Prote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Compan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Catalo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Hos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pplicatio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5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ffffff"/>
                          </a:solidFill>
                          <a:latin typeface="Arial"/>
                          <a:ea typeface="Arial"/>
                        </a:rPr>
                        <a:t>        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ilutio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57852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F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Abcam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ab19905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Rabbi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      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WB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    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      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IF 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       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1:10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       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1:2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55728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COL 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Thermo Fisher Scientifi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PA1-2620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Rabbi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      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W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  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      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I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       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1:10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       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1:2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57924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TGF-</a:t>
                      </a:r>
                      <a:r>
                        <a:rPr b="1" lang="el-GR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β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novusbi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NBP1-8028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Rabbi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      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W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 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      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I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       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1:10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       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1:2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7008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l-GR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α-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TUBUL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Santa Cruz Biotechnolog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SC-528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Mous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      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W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       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1:10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7152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GADPH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Santa Cruz Biotechnolog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SC-2577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Rabbi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marL="166680">
                        <a:lnSpc>
                          <a:spcPct val="100000"/>
                        </a:lnSpc>
                        <a:spcBef>
                          <a:spcPts val="1287"/>
                        </a:spcBef>
                        <a:tabLst>
                          <a:tab algn="l" pos="0"/>
                          <a:tab algn="l" pos="1425600"/>
                          <a:tab algn="l" pos="2955960"/>
                          <a:tab algn="l" pos="3765600"/>
                          <a:tab algn="l" pos="4394160"/>
                          <a:tab algn="l" pos="511488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W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marL="166680">
                        <a:lnSpc>
                          <a:spcPct val="100000"/>
                        </a:lnSpc>
                        <a:spcBef>
                          <a:spcPts val="1287"/>
                        </a:spcBef>
                        <a:tabLst>
                          <a:tab algn="l" pos="0"/>
                          <a:tab algn="l" pos="1425600"/>
                          <a:tab algn="l" pos="2955960"/>
                          <a:tab algn="l" pos="3765600"/>
                          <a:tab algn="l" pos="4394160"/>
                          <a:tab algn="l" pos="511488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 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1:10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6972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β-ACT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Santa Cruz Biotechnolog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SC-8117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Mous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marL="166680">
                        <a:lnSpc>
                          <a:spcPct val="100000"/>
                        </a:lnSpc>
                        <a:spcBef>
                          <a:spcPts val="1287"/>
                        </a:spcBef>
                        <a:tabLst>
                          <a:tab algn="l" pos="0"/>
                          <a:tab algn="l" pos="1425600"/>
                          <a:tab algn="l" pos="2955960"/>
                          <a:tab algn="l" pos="3765600"/>
                          <a:tab algn="l" pos="4394160"/>
                          <a:tab algn="l" pos="511488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W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marL="166680">
                        <a:lnSpc>
                          <a:spcPct val="100000"/>
                        </a:lnSpc>
                        <a:spcBef>
                          <a:spcPts val="1287"/>
                        </a:spcBef>
                        <a:tabLst>
                          <a:tab algn="l" pos="0"/>
                          <a:tab algn="l" pos="1425600"/>
                          <a:tab algn="l" pos="2955960"/>
                          <a:tab algn="l" pos="3765600"/>
                          <a:tab algn="l" pos="4394160"/>
                          <a:tab algn="l" pos="511488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 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1:10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7152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Goat anti Mouse Ig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Santa Cruz Biotechnolog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SC-203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Goa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      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W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       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1:10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7008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Goat anti Rabbit Ig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Thermo Fisher Scientifi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3146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Goa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      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W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       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1:10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7080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Alexa Fluor® 56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Thermo Fisher Scientifi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A1103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Goa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       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I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25320"/>
                          <a:tab algn="l" pos="1251000"/>
                          <a:tab algn="l" pos="1876320"/>
                          <a:tab algn="l" pos="2502000"/>
                          <a:tab algn="l" pos="3127320"/>
                          <a:tab algn="l" pos="3753000"/>
                          <a:tab algn="l" pos="4378320"/>
                          <a:tab algn="l" pos="5003640"/>
                          <a:tab algn="l" pos="5629320"/>
                          <a:tab algn="l" pos="6254640"/>
                          <a:tab algn="l" pos="6880320"/>
                          <a:tab algn="l" pos="7505640"/>
                          <a:tab algn="l" pos="8131320"/>
                          <a:tab algn="l" pos="8756640"/>
                          <a:tab algn="l" pos="9381960"/>
                          <a:tab algn="l" pos="10007640"/>
                          <a:tab algn="l" pos="1063296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       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等线"/>
                        </a:rPr>
                        <a:t>1:2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119" name="矩形 13"/>
          <p:cNvSpPr/>
          <p:nvPr/>
        </p:nvSpPr>
        <p:spPr>
          <a:xfrm>
            <a:off x="246240" y="5248440"/>
            <a:ext cx="5275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17600"/>
                <a:tab algn="l" pos="835200"/>
                <a:tab algn="l" pos="1252440"/>
                <a:tab algn="l" pos="1670040"/>
                <a:tab algn="l" pos="2087640"/>
                <a:tab algn="l" pos="2505240"/>
                <a:tab algn="l" pos="2922480"/>
                <a:tab algn="l" pos="3340080"/>
                <a:tab algn="l" pos="3757680"/>
                <a:tab algn="l" pos="4175280"/>
                <a:tab algn="l" pos="4592520"/>
                <a:tab algn="l" pos="5010120"/>
                <a:tab algn="l" pos="5427720"/>
                <a:tab algn="l" pos="5845320"/>
                <a:tab algn="l" pos="6262560"/>
                <a:tab algn="l" pos="6680160"/>
                <a:tab algn="l" pos="7097760"/>
                <a:tab algn="l" pos="7515360"/>
                <a:tab algn="l" pos="7932600"/>
                <a:tab algn="l" pos="83502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等线"/>
              </a:rPr>
              <a:t>Abbreviations: FN, Fibronectin ;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等线"/>
              </a:rPr>
              <a:t>COL 1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,Collagen 1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等线"/>
              </a:rPr>
              <a:t> ;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等线"/>
              </a:rPr>
              <a:t>TGF-β1, transforming growth factor </a:t>
            </a:r>
            <a:r>
              <a:rPr b="1" lang="el-GR" sz="800" spc="-1" strike="noStrike">
                <a:solidFill>
                  <a:srgbClr val="000000"/>
                </a:solidFill>
                <a:latin typeface="Arial"/>
                <a:ea typeface="等线"/>
              </a:rPr>
              <a:t>β1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等线"/>
              </a:rPr>
              <a:t>; GADPH, glyceraldehyde-3-phosphate dehydrogenase; WB, western blot; IF, Immunofluorescence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81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09-03T03:54:11Z</dcterms:created>
  <dc:creator>Lenovo</dc:creator>
  <dc:description/>
  <dc:language>en-US</dc:language>
  <cp:lastModifiedBy>cmu2h.yanwu@163.com</cp:lastModifiedBy>
  <dcterms:modified xsi:type="dcterms:W3CDTF">2021-05-25T02:36:50Z</dcterms:modified>
  <cp:revision>829</cp:revision>
  <dc:subject/>
  <dc:title>PowerPoint 演示文稿</dc:title>
</cp:coreProperties>
</file>